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96" y="30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7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636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319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1139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1903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836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66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741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55180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335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026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0AF20D-B594-47A1-BDD6-68E1E4D29025}" type="datetimeFigureOut">
              <a:rPr lang="en-US" smtClean="0"/>
              <a:t>5/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732873-C01B-495A-B23D-BD602BF6A1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318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76400" y="4572000"/>
            <a:ext cx="3499556" cy="990600"/>
          </a:xfrm>
        </p:spPr>
        <p:txBody>
          <a:bodyPr>
            <a:noAutofit/>
          </a:bodyPr>
          <a:lstStyle/>
          <a:p>
            <a:pPr algn="l"/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</a:t>
            </a: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:  </a:t>
            </a: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ME output of the motifs </a:t>
            </a:r>
            <a:r>
              <a:rPr lang="en-US" sz="12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scovered </a:t>
            </a:r>
            <a:r>
              <a:rPr lang="en-US" sz="12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en-US" sz="120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tron 7 in 81 </a:t>
            </a:r>
            <a:r>
              <a:rPr lang="en-US" sz="1200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CB1 </a:t>
            </a:r>
            <a:r>
              <a:rPr lang="en-US" sz="1200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rthologs</a:t>
            </a: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27 monocots, 32 dicots and the basal </a:t>
            </a:r>
            <a:r>
              <a:rPr lang="en-US" sz="12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giosperm </a:t>
            </a:r>
            <a:r>
              <a:rPr lang="en-US" sz="1200" i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mborella</a:t>
            </a:r>
            <a:r>
              <a:rPr lang="en-US" sz="1200" i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ichopoda</a:t>
            </a:r>
            <a:endParaRPr 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77" t="8000" r="53894" b="20000"/>
          <a:stretch/>
        </p:blipFill>
        <p:spPr bwMode="auto">
          <a:xfrm>
            <a:off x="1752600" y="1219200"/>
            <a:ext cx="3499556" cy="304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414493" y="838200"/>
            <a:ext cx="633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ogo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038600" y="838200"/>
            <a:ext cx="868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-valu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1584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92</TotalTime>
  <Words>3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iv Parvathaneni</dc:creator>
  <cp:lastModifiedBy>Katrien M. Devos</cp:lastModifiedBy>
  <cp:revision>8</cp:revision>
  <dcterms:created xsi:type="dcterms:W3CDTF">2017-01-12T21:58:41Z</dcterms:created>
  <dcterms:modified xsi:type="dcterms:W3CDTF">2017-05-05T13:46:39Z</dcterms:modified>
</cp:coreProperties>
</file>